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9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9086F0-2C37-5DE1-C34D-F00F4629F619}" v="1444" dt="2025-06-04T18:51:29.681"/>
    <p1510:client id="{0874E646-EC97-1512-A2A8-E71BD479369D}" v="6" dt="2025-06-04T15:15:52.442"/>
    <p1510:client id="{34D54C23-350A-0AD2-8DE1-0209BABF7BC1}" v="115" dt="2025-06-04T15:01:34.575"/>
    <p1510:client id="{3887DAEF-AFE3-2140-B2D4-4ED602B64044}" v="27" dt="2025-06-04T19:09:21.769"/>
    <p1510:client id="{55D52541-6774-4949-865A-8900D79EFBC7}" v="49" dt="2025-06-04T15:38:13.454"/>
    <p1510:client id="{B808C385-B51E-1C22-646C-B1EF128E60B1}" v="130" dt="2025-06-03T19:12:57.402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68"/>
    <p:restoredTop sz="94609"/>
  </p:normalViewPr>
  <p:slideViewPr>
    <p:cSldViewPr snapToGrid="0">
      <p:cViewPr varScale="1">
        <p:scale>
          <a:sx n="113" d="100"/>
          <a:sy n="113" d="100"/>
        </p:scale>
        <p:origin x="33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7805520-C0FB-6FD7-6E2D-6F115AD6C86C}"/>
              </a:ext>
            </a:extLst>
          </p:cNvPr>
          <p:cNvSpPr txBox="1"/>
          <p:nvPr/>
        </p:nvSpPr>
        <p:spPr>
          <a:xfrm>
            <a:off x="119550" y="5208958"/>
            <a:ext cx="6533198" cy="70788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alt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Supplementary Table S1. ICI Therapy Type per Cancer Type (N).  Displays the number of patients receiving ICI per cancer type. 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ICI therapies that are given in combination are only counted once under the respective therapy type listed. 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Pembro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=pembrolizumab, Nivo=nivolumab, 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Ipi+Nivo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=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ipilumumab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 + nivolumab, 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Atezo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=atezolizumab, Ave=avelumab, 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Cemi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=</a:t>
            </a:r>
            <a:r>
              <a:rPr lang="en-US" sz="1000" dirty="0" err="1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cemiplimab</a:t>
            </a:r>
            <a:r>
              <a:rPr lang="en-US" sz="10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, Durva=durvalumab</a:t>
            </a:r>
            <a:endParaRPr lang="en-US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F9F851E-9B1E-CDE8-5AF5-769182E166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041507"/>
              </p:ext>
            </p:extLst>
          </p:nvPr>
        </p:nvGraphicFramePr>
        <p:xfrm>
          <a:off x="199590" y="1502402"/>
          <a:ext cx="6453158" cy="3351278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1524457">
                  <a:extLst>
                    <a:ext uri="{9D8B030D-6E8A-4147-A177-3AD203B41FA5}">
                      <a16:colId xmlns:a16="http://schemas.microsoft.com/office/drawing/2014/main" val="1473754998"/>
                    </a:ext>
                  </a:extLst>
                </a:gridCol>
                <a:gridCol w="709891">
                  <a:extLst>
                    <a:ext uri="{9D8B030D-6E8A-4147-A177-3AD203B41FA5}">
                      <a16:colId xmlns:a16="http://schemas.microsoft.com/office/drawing/2014/main" val="542383754"/>
                    </a:ext>
                  </a:extLst>
                </a:gridCol>
                <a:gridCol w="555728">
                  <a:extLst>
                    <a:ext uri="{9D8B030D-6E8A-4147-A177-3AD203B41FA5}">
                      <a16:colId xmlns:a16="http://schemas.microsoft.com/office/drawing/2014/main" val="2165280430"/>
                    </a:ext>
                  </a:extLst>
                </a:gridCol>
                <a:gridCol w="829786">
                  <a:extLst>
                    <a:ext uri="{9D8B030D-6E8A-4147-A177-3AD203B41FA5}">
                      <a16:colId xmlns:a16="http://schemas.microsoft.com/office/drawing/2014/main" val="3896870942"/>
                    </a:ext>
                  </a:extLst>
                </a:gridCol>
                <a:gridCol w="662306">
                  <a:extLst>
                    <a:ext uri="{9D8B030D-6E8A-4147-A177-3AD203B41FA5}">
                      <a16:colId xmlns:a16="http://schemas.microsoft.com/office/drawing/2014/main" val="1433583661"/>
                    </a:ext>
                  </a:extLst>
                </a:gridCol>
                <a:gridCol w="502438">
                  <a:extLst>
                    <a:ext uri="{9D8B030D-6E8A-4147-A177-3AD203B41FA5}">
                      <a16:colId xmlns:a16="http://schemas.microsoft.com/office/drawing/2014/main" val="13774668"/>
                    </a:ext>
                  </a:extLst>
                </a:gridCol>
                <a:gridCol w="601404">
                  <a:extLst>
                    <a:ext uri="{9D8B030D-6E8A-4147-A177-3AD203B41FA5}">
                      <a16:colId xmlns:a16="http://schemas.microsoft.com/office/drawing/2014/main" val="910950509"/>
                    </a:ext>
                  </a:extLst>
                </a:gridCol>
                <a:gridCol w="546901">
                  <a:extLst>
                    <a:ext uri="{9D8B030D-6E8A-4147-A177-3AD203B41FA5}">
                      <a16:colId xmlns:a16="http://schemas.microsoft.com/office/drawing/2014/main" val="1354879707"/>
                    </a:ext>
                  </a:extLst>
                </a:gridCol>
                <a:gridCol w="520247">
                  <a:extLst>
                    <a:ext uri="{9D8B030D-6E8A-4147-A177-3AD203B41FA5}">
                      <a16:colId xmlns:a16="http://schemas.microsoft.com/office/drawing/2014/main" val="1457859782"/>
                    </a:ext>
                  </a:extLst>
                </a:gridCol>
              </a:tblGrid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ancer Typ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embro</a:t>
                      </a:r>
                      <a:endParaRPr lang="en-US" sz="1000" b="1" u="none" strike="noStrike" err="1"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ivo</a:t>
                      </a: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pi + Nivo</a:t>
                      </a: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tezo</a:t>
                      </a:r>
                      <a:endParaRPr lang="en-US" sz="1000" b="1" u="none" strike="noStrike" err="1"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ve</a:t>
                      </a: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emi</a:t>
                      </a:r>
                      <a:endParaRPr lang="en-US" sz="1000" b="1" u="none" strike="noStrike" err="1"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Durva</a:t>
                      </a: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otal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73101138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Breast can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1789304915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olorectal can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1513175874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Endometrial canc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508157792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Gastroesophageal can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584872746"/>
                  </a:ext>
                </a:extLst>
              </a:tr>
              <a:tr h="3391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ead and neck squamous cell cancer (HNSCC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482934236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epatocellular carcinom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1287903438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elanom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3763584890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erkel cell carcinoma (MCC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1831984461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Non-small cell lung cancer (NSCLC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2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4218318921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rostate can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356730824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enal cell carcinoma (RCC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893567673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Small cell lung canc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441517715"/>
                  </a:ext>
                </a:extLst>
              </a:tr>
              <a:tr h="1046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Urothelial carcinoma (UC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4151455058"/>
                  </a:ext>
                </a:extLst>
              </a:tr>
              <a:tr h="1923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ot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Helvetica Neue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2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Helvetica Neue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338" marR="5338" marT="5338" marB="0" anchor="ctr"/>
                </a:tc>
                <a:extLst>
                  <a:ext uri="{0D108BD9-81ED-4DB2-BD59-A6C34878D82A}">
                    <a16:rowId xmlns:a16="http://schemas.microsoft.com/office/drawing/2014/main" val="229675932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E4EE626-C784-D794-E756-E8A806486EEE}"/>
              </a:ext>
            </a:extLst>
          </p:cNvPr>
          <p:cNvSpPr txBox="1"/>
          <p:nvPr/>
        </p:nvSpPr>
        <p:spPr>
          <a:xfrm>
            <a:off x="119550" y="777792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8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Supplementary Tabl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7723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9</TotalTime>
  <Words>206</Words>
  <Application>Microsoft Macintosh PowerPoint</Application>
  <PresentationFormat>Letter Paper (8.5x11 in)</PresentationFormat>
  <Paragraphs>9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4</cp:revision>
  <dcterms:created xsi:type="dcterms:W3CDTF">2024-12-13T18:22:33Z</dcterms:created>
  <dcterms:modified xsi:type="dcterms:W3CDTF">2025-07-09T17:03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